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80" d="100"/>
          <a:sy n="80" d="100"/>
        </p:scale>
        <p:origin x="136" y="-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633634D-C883-1996-AEA2-CD9B83EE6D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C4F8E946-8D19-0535-6965-1FD17CBE19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EE8050C-86A1-56C7-5B09-EBB68C6F21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34CD3-4EC5-4B26-92B5-22B1B8B4DA8D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AC77A95-266F-C574-E36F-BB51270509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BA6E56D-4E18-BB80-BEF3-3AB12385EE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0607-1C57-4F89-8FDB-1AAAB47EA7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38739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1CEDDF4-2F6A-CD6D-ECF7-CE2A735D62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21DB3ED-A39F-8B0F-E9FC-BED4C653F3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C237C8F-64C4-6731-60A5-2D9167A507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34CD3-4EC5-4B26-92B5-22B1B8B4DA8D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8F65E07-998D-5EEB-B873-EFE173165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E29770F-60AD-22F9-2B2B-6792F2DECD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0607-1C57-4F89-8FDB-1AAAB47EA7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7108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A172CC90-8551-A3F6-542A-046D0DBA65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DA0FE55-3523-9AB5-4FBB-81DBE32946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37AD9FF-E887-D088-F408-5804A38672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34CD3-4EC5-4B26-92B5-22B1B8B4DA8D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F901C53-5A41-6D4A-6AA3-85096BF39B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3B0E331-463E-70A1-1451-F441CB49DB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0607-1C57-4F89-8FDB-1AAAB47EA7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7180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51FB5EE-160F-09B4-1826-28F9A7CC95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537F209-A178-D024-178E-66628757B4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1838102-D02E-32D0-BF28-467DBC6C93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34CD3-4EC5-4B26-92B5-22B1B8B4DA8D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918C91B-9C4B-F0DE-60ED-EB81F0767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02F973B-B9F1-A683-71A5-1BF06B9262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0607-1C57-4F89-8FDB-1AAAB47EA7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1253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6A66DC-E6C5-BDA8-25F1-168365BCDF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7B2C163-A1DA-9C30-EE94-BC00636F38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62C5FDA-DD4E-914C-A558-7F39151969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34CD3-4EC5-4B26-92B5-22B1B8B4DA8D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86D7B2F-B5CB-154A-451E-22991F96CD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B2BBFA8-19ED-E6D8-10D6-513954515F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0607-1C57-4F89-8FDB-1AAAB47EA7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3788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54305F0-65AB-1248-A696-49AC35A471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33289D2-2DFF-76D0-4F47-F5BFE11201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C38BB58-D926-F64D-4C92-93F5092080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38EDED7-3A2D-9CB8-D17C-D442C7AE3A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34CD3-4EC5-4B26-92B5-22B1B8B4DA8D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E7AA013-68B1-8977-E923-DD6B6D267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9CA3DD5-FB7F-5817-2FBF-1CE864D8DE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0607-1C57-4F89-8FDB-1AAAB47EA7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8634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C7F218E-92AE-C6D7-63A4-8C725EB73A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21A4DFE-A2F5-21A0-E30A-E25BF9EA7A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A073148-CE2E-1062-93B7-7A0A056E27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C2F0BD84-510C-F5C5-1670-813F4C6DC1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E7EEA86-53C1-443C-4B1A-C1D7C6C1C3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2A869AB-EBE6-8B0D-78BE-1B81B9B11B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34CD3-4EC5-4B26-92B5-22B1B8B4DA8D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A24171A4-164E-33DA-E4FF-1966FC426D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E906F2E5-A066-3EB4-7E6E-EE524ED31F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0607-1C57-4F89-8FDB-1AAAB47EA7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9221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C25713E-DC02-C1EC-C075-1284E8495F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4EB7442A-2E7B-2E5E-9684-4374E6CF92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34CD3-4EC5-4B26-92B5-22B1B8B4DA8D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AE7BE46B-829D-83EE-F860-077243E8D7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CA0E1766-0319-BD9F-4AC9-89E7857B24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0607-1C57-4F89-8FDB-1AAAB47EA7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66586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2B9D997D-1A38-9682-6D6C-2E09103BDE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34CD3-4EC5-4B26-92B5-22B1B8B4DA8D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A90B036-C3FF-12CD-99D0-056E2C1A4B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87E5C35-869D-2E41-DBEE-917FF1A2E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0607-1C57-4F89-8FDB-1AAAB47EA7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0306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478BB1C-204F-EE17-E067-80066FCFBF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B99E295-9613-FBEE-682B-07F9746EAA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59E310A6-9FF4-B428-3665-997DF8CE04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7158BA2-F626-5C9F-8957-79AB1ED60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34CD3-4EC5-4B26-92B5-22B1B8B4DA8D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A8BE19F-3105-E426-9154-9C0130F404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2C8BA42-C123-1D38-6C67-1B538EA7DA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0607-1C57-4F89-8FDB-1AAAB47EA7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4138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99D4107-FF62-06F8-84BA-1EA298B3DC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EAAF022D-318D-0683-13DF-F483A35381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6E1A784-D820-D6B1-5FFF-6F737F737A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D641068-CBB8-593C-2E57-90D4DD49C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34CD3-4EC5-4B26-92B5-22B1B8B4DA8D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3DC77BC-71EE-D61D-B93E-334A88AA3A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34847FF-3AB8-EF69-60E7-B79F5849D8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0607-1C57-4F89-8FDB-1AAAB47EA7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5091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8395AC37-E40A-0EBE-B0EC-43D33AB58E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5550202-CB1E-D5A4-C886-00C507CA08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B24F161-AD06-E7BF-FE3B-16BF5855D3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5C34CD3-4EC5-4B26-92B5-22B1B8B4DA8D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DAF985A-C1AD-73F6-5ACB-E61297C8DD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E446364-22F5-F361-8CE7-09B3A54FD4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6C0607-1C57-4F89-8FDB-1AAAB47EA7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8469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Image 32">
            <a:extLst>
              <a:ext uri="{FF2B5EF4-FFF2-40B4-BE49-F238E27FC236}">
                <a16:creationId xmlns:a16="http://schemas.microsoft.com/office/drawing/2014/main" id="{12121779-4BF6-C542-06B8-730223F685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90237" y="489906"/>
            <a:ext cx="3455707" cy="2299474"/>
          </a:xfrm>
          <a:prstGeom prst="rect">
            <a:avLst/>
          </a:prstGeom>
        </p:spPr>
      </p:pic>
      <p:pic>
        <p:nvPicPr>
          <p:cNvPr id="34" name="Image 33">
            <a:extLst>
              <a:ext uri="{FF2B5EF4-FFF2-40B4-BE49-F238E27FC236}">
                <a16:creationId xmlns:a16="http://schemas.microsoft.com/office/drawing/2014/main" id="{02FA64EA-B901-2D8D-FAE2-EE4B3D63973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90237" y="2864427"/>
            <a:ext cx="3619386" cy="2408388"/>
          </a:xfrm>
          <a:prstGeom prst="rect">
            <a:avLst/>
          </a:prstGeom>
        </p:spPr>
      </p:pic>
      <p:pic>
        <p:nvPicPr>
          <p:cNvPr id="36" name="Image 35">
            <a:extLst>
              <a:ext uri="{FF2B5EF4-FFF2-40B4-BE49-F238E27FC236}">
                <a16:creationId xmlns:a16="http://schemas.microsoft.com/office/drawing/2014/main" id="{DDDA0054-6EB7-6CDC-BDE1-2A63AACD2A38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-2775"/>
          <a:stretch/>
        </p:blipFill>
        <p:spPr>
          <a:xfrm>
            <a:off x="900258" y="779659"/>
            <a:ext cx="2412285" cy="2572735"/>
          </a:xfrm>
          <a:prstGeom prst="rect">
            <a:avLst/>
          </a:prstGeom>
        </p:spPr>
      </p:pic>
      <p:sp>
        <p:nvSpPr>
          <p:cNvPr id="37" name="TextBox 31">
            <a:extLst>
              <a:ext uri="{FF2B5EF4-FFF2-40B4-BE49-F238E27FC236}">
                <a16:creationId xmlns:a16="http://schemas.microsoft.com/office/drawing/2014/main" id="{CF58A2AA-64D2-3145-70AE-223128D59261}"/>
              </a:ext>
            </a:extLst>
          </p:cNvPr>
          <p:cNvSpPr txBox="1"/>
          <p:nvPr/>
        </p:nvSpPr>
        <p:spPr>
          <a:xfrm>
            <a:off x="3245383" y="1005709"/>
            <a:ext cx="1286522" cy="4462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R" sz="1100" b="1" dirty="0">
                <a:latin typeface="Arial" panose="020B0604020202020204" pitchFamily="34" charset="0"/>
                <a:cs typeface="Arial" panose="020B0604020202020204" pitchFamily="34" charset="0"/>
              </a:rPr>
              <a:t>YFP:Kin-12F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anti-GFP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2">
            <a:extLst>
              <a:ext uri="{FF2B5EF4-FFF2-40B4-BE49-F238E27FC236}">
                <a16:creationId xmlns:a16="http://schemas.microsoft.com/office/drawing/2014/main" id="{723C39EF-81D8-501F-93BB-38EA6120745F}"/>
              </a:ext>
            </a:extLst>
          </p:cNvPr>
          <p:cNvSpPr txBox="1"/>
          <p:nvPr/>
        </p:nvSpPr>
        <p:spPr>
          <a:xfrm>
            <a:off x="3247178" y="1639643"/>
            <a:ext cx="13595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R" sz="1200" b="1" dirty="0">
                <a:latin typeface="Arial" panose="020B0604020202020204" pitchFamily="34" charset="0"/>
                <a:cs typeface="Arial" panose="020B0604020202020204" pitchFamily="34" charset="0"/>
              </a:rPr>
              <a:t>mCh:RAB-A2a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(anti-RAB-A2a)</a:t>
            </a:r>
            <a:endParaRPr lang="en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3">
            <a:extLst>
              <a:ext uri="{FF2B5EF4-FFF2-40B4-BE49-F238E27FC236}">
                <a16:creationId xmlns:a16="http://schemas.microsoft.com/office/drawing/2014/main" id="{D288DEB6-CBB7-E952-890F-5C2C762A12E6}"/>
              </a:ext>
            </a:extLst>
          </p:cNvPr>
          <p:cNvSpPr txBox="1"/>
          <p:nvPr/>
        </p:nvSpPr>
        <p:spPr>
          <a:xfrm rot="5400000">
            <a:off x="-2861444" y="1380542"/>
            <a:ext cx="725505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FR" sz="1050" b="1" dirty="0">
                <a:latin typeface="Arial" panose="020B0604020202020204" pitchFamily="34" charset="0"/>
                <a:cs typeface="Arial" panose="020B0604020202020204" pitchFamily="34" charset="0"/>
              </a:rPr>
              <a:t>luted beads</a:t>
            </a:r>
          </a:p>
        </p:txBody>
      </p:sp>
      <p:sp>
        <p:nvSpPr>
          <p:cNvPr id="40" name="TextBox 41">
            <a:extLst>
              <a:ext uri="{FF2B5EF4-FFF2-40B4-BE49-F238E27FC236}">
                <a16:creationId xmlns:a16="http://schemas.microsoft.com/office/drawing/2014/main" id="{491DD1C0-3974-2515-43BD-856A1AFD4F3C}"/>
              </a:ext>
            </a:extLst>
          </p:cNvPr>
          <p:cNvSpPr txBox="1"/>
          <p:nvPr/>
        </p:nvSpPr>
        <p:spPr>
          <a:xfrm rot="5400000">
            <a:off x="-2264552" y="2574260"/>
            <a:ext cx="61000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Total protein</a:t>
            </a:r>
            <a:endParaRPr lang="en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51">
            <a:extLst>
              <a:ext uri="{FF2B5EF4-FFF2-40B4-BE49-F238E27FC236}">
                <a16:creationId xmlns:a16="http://schemas.microsoft.com/office/drawing/2014/main" id="{581A16A7-A76B-78F9-9BCD-3319F84B25D4}"/>
              </a:ext>
            </a:extLst>
          </p:cNvPr>
          <p:cNvSpPr txBox="1"/>
          <p:nvPr/>
        </p:nvSpPr>
        <p:spPr>
          <a:xfrm>
            <a:off x="3124583" y="579180"/>
            <a:ext cx="7908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R" sz="1600" b="1" dirty="0">
                <a:latin typeface="Arial" panose="020B0604020202020204" pitchFamily="34" charset="0"/>
                <a:cs typeface="Arial" panose="020B0604020202020204" pitchFamily="34" charset="0"/>
              </a:rPr>
              <a:t>Dex</a:t>
            </a:r>
          </a:p>
        </p:txBody>
      </p:sp>
      <p:sp>
        <p:nvSpPr>
          <p:cNvPr id="42" name="TextBox 32">
            <a:extLst>
              <a:ext uri="{FF2B5EF4-FFF2-40B4-BE49-F238E27FC236}">
                <a16:creationId xmlns:a16="http://schemas.microsoft.com/office/drawing/2014/main" id="{413602EF-BF2D-87A7-14E6-13CDC751B86E}"/>
              </a:ext>
            </a:extLst>
          </p:cNvPr>
          <p:cNvSpPr txBox="1"/>
          <p:nvPr/>
        </p:nvSpPr>
        <p:spPr>
          <a:xfrm>
            <a:off x="3214454" y="2784183"/>
            <a:ext cx="17745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R" sz="1200" b="1" dirty="0">
                <a:latin typeface="Arial" panose="020B0604020202020204" pitchFamily="34" charset="0"/>
                <a:cs typeface="Arial" panose="020B0604020202020204" pitchFamily="34" charset="0"/>
              </a:rPr>
              <a:t>mCh:RAB-A2a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(anti-RAB-A2a)</a:t>
            </a:r>
            <a:endParaRPr lang="en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31">
            <a:extLst>
              <a:ext uri="{FF2B5EF4-FFF2-40B4-BE49-F238E27FC236}">
                <a16:creationId xmlns:a16="http://schemas.microsoft.com/office/drawing/2014/main" id="{F1FCF571-49A7-A5FA-10C3-61C01A04E1C0}"/>
              </a:ext>
            </a:extLst>
          </p:cNvPr>
          <p:cNvSpPr txBox="1"/>
          <p:nvPr/>
        </p:nvSpPr>
        <p:spPr>
          <a:xfrm>
            <a:off x="3214454" y="2176270"/>
            <a:ext cx="12865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R" sz="1200" b="1" dirty="0">
                <a:latin typeface="Arial" panose="020B0604020202020204" pitchFamily="34" charset="0"/>
                <a:cs typeface="Arial" panose="020B0604020202020204" pitchFamily="34" charset="0"/>
              </a:rPr>
              <a:t>YFP:Kin-12F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(anti-GFP)</a:t>
            </a:r>
            <a:endParaRPr lang="en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7E046C93-156B-0500-BB6F-9BA0A0D64B5B}"/>
              </a:ext>
            </a:extLst>
          </p:cNvPr>
          <p:cNvSpPr/>
          <p:nvPr/>
        </p:nvSpPr>
        <p:spPr>
          <a:xfrm>
            <a:off x="6684381" y="717630"/>
            <a:ext cx="960698" cy="2880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956AB4C3-FAF2-E98F-0E6F-042083FAB713}"/>
              </a:ext>
            </a:extLst>
          </p:cNvPr>
          <p:cNvSpPr/>
          <p:nvPr/>
        </p:nvSpPr>
        <p:spPr>
          <a:xfrm>
            <a:off x="6684381" y="1363460"/>
            <a:ext cx="960698" cy="2880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AF94002A-C186-335A-8D5C-4075104BF5A8}"/>
              </a:ext>
            </a:extLst>
          </p:cNvPr>
          <p:cNvSpPr/>
          <p:nvPr/>
        </p:nvSpPr>
        <p:spPr>
          <a:xfrm>
            <a:off x="6786315" y="3208354"/>
            <a:ext cx="960698" cy="2880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8F139C5D-23EC-8106-49C9-D866DD136638}"/>
              </a:ext>
            </a:extLst>
          </p:cNvPr>
          <p:cNvSpPr/>
          <p:nvPr/>
        </p:nvSpPr>
        <p:spPr>
          <a:xfrm>
            <a:off x="6684381" y="3840361"/>
            <a:ext cx="1012784" cy="3723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9" name="TextBox 31">
            <a:extLst>
              <a:ext uri="{FF2B5EF4-FFF2-40B4-BE49-F238E27FC236}">
                <a16:creationId xmlns:a16="http://schemas.microsoft.com/office/drawing/2014/main" id="{162F52D4-B0F5-2115-25FF-96E81BADC680}"/>
              </a:ext>
            </a:extLst>
          </p:cNvPr>
          <p:cNvSpPr txBox="1"/>
          <p:nvPr/>
        </p:nvSpPr>
        <p:spPr>
          <a:xfrm>
            <a:off x="7603085" y="539424"/>
            <a:ext cx="12865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w 1</a:t>
            </a:r>
            <a:endParaRPr lang="en-FR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31">
            <a:extLst>
              <a:ext uri="{FF2B5EF4-FFF2-40B4-BE49-F238E27FC236}">
                <a16:creationId xmlns:a16="http://schemas.microsoft.com/office/drawing/2014/main" id="{57507907-46B2-2785-F1E0-609234AE8B4B}"/>
              </a:ext>
            </a:extLst>
          </p:cNvPr>
          <p:cNvSpPr txBox="1"/>
          <p:nvPr/>
        </p:nvSpPr>
        <p:spPr>
          <a:xfrm>
            <a:off x="7603085" y="1247145"/>
            <a:ext cx="12865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w 2</a:t>
            </a:r>
            <a:endParaRPr lang="en-FR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31">
            <a:extLst>
              <a:ext uri="{FF2B5EF4-FFF2-40B4-BE49-F238E27FC236}">
                <a16:creationId xmlns:a16="http://schemas.microsoft.com/office/drawing/2014/main" id="{C326D1ED-2B93-DC87-AE44-7ECED50670A8}"/>
              </a:ext>
            </a:extLst>
          </p:cNvPr>
          <p:cNvSpPr txBox="1"/>
          <p:nvPr/>
        </p:nvSpPr>
        <p:spPr>
          <a:xfrm>
            <a:off x="7705019" y="3044617"/>
            <a:ext cx="12865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w 3</a:t>
            </a:r>
            <a:endParaRPr lang="en-FR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31">
            <a:extLst>
              <a:ext uri="{FF2B5EF4-FFF2-40B4-BE49-F238E27FC236}">
                <a16:creationId xmlns:a16="http://schemas.microsoft.com/office/drawing/2014/main" id="{EBC9630C-4177-8692-96FB-0CE7565B10B8}"/>
              </a:ext>
            </a:extLst>
          </p:cNvPr>
          <p:cNvSpPr txBox="1"/>
          <p:nvPr/>
        </p:nvSpPr>
        <p:spPr>
          <a:xfrm>
            <a:off x="7645079" y="3628795"/>
            <a:ext cx="12865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w 4</a:t>
            </a:r>
            <a:endParaRPr lang="en-FR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777528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</Words>
  <Application>Microsoft Office PowerPoint</Application>
  <PresentationFormat>Grand écran</PresentationFormat>
  <Paragraphs>1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am Elliott</dc:creator>
  <cp:lastModifiedBy>Liam Elliott</cp:lastModifiedBy>
  <cp:revision>1</cp:revision>
  <dcterms:created xsi:type="dcterms:W3CDTF">2026-03-28T14:44:07Z</dcterms:created>
  <dcterms:modified xsi:type="dcterms:W3CDTF">2026-03-28T14:44:17Z</dcterms:modified>
</cp:coreProperties>
</file>